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60" r:id="rId3"/>
    <p:sldId id="261" r:id="rId4"/>
    <p:sldId id="262" r:id="rId5"/>
  </p:sldIdLst>
  <p:sldSz cx="6858000" cy="9906000" type="A4"/>
  <p:notesSz cx="6797675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alte Bonin" initials="MB" lastIdx="4" clrIdx="0">
    <p:extLst>
      <p:ext uri="{19B8F6BF-5375-455C-9EA6-DF929625EA0E}">
        <p15:presenceInfo xmlns:p15="http://schemas.microsoft.com/office/powerpoint/2012/main" userId="Malte Bonin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78" d="100"/>
          <a:sy n="78" d="100"/>
        </p:scale>
        <p:origin x="3030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commentAuthors" Target="commentAuthors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 smtClean="0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0B290C-3CC6-49F1-BA49-84934B59FCC5}" type="datetimeFigureOut">
              <a:rPr lang="en-US" smtClean="0"/>
              <a:t>1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3995E8-7E87-4611-A1FF-EF204549B9B1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95807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0B290C-3CC6-49F1-BA49-84934B59FCC5}" type="datetimeFigureOut">
              <a:rPr lang="en-US" smtClean="0"/>
              <a:t>1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3995E8-7E87-4611-A1FF-EF204549B9B1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44333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0B290C-3CC6-49F1-BA49-84934B59FCC5}" type="datetimeFigureOut">
              <a:rPr lang="en-US" smtClean="0"/>
              <a:t>1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3995E8-7E87-4611-A1FF-EF204549B9B1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00335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0B290C-3CC6-49F1-BA49-84934B59FCC5}" type="datetimeFigureOut">
              <a:rPr lang="en-US" smtClean="0"/>
              <a:t>1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3995E8-7E87-4611-A1FF-EF204549B9B1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84958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0B290C-3CC6-49F1-BA49-84934B59FCC5}" type="datetimeFigureOut">
              <a:rPr lang="en-US" smtClean="0"/>
              <a:t>1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3995E8-7E87-4611-A1FF-EF204549B9B1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44549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0B290C-3CC6-49F1-BA49-84934B59FCC5}" type="datetimeFigureOut">
              <a:rPr lang="en-US" smtClean="0"/>
              <a:t>1/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3995E8-7E87-4611-A1FF-EF204549B9B1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65158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0B290C-3CC6-49F1-BA49-84934B59FCC5}" type="datetimeFigureOut">
              <a:rPr lang="en-US" smtClean="0"/>
              <a:t>1/2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3995E8-7E87-4611-A1FF-EF204549B9B1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78455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0B290C-3CC6-49F1-BA49-84934B59FCC5}" type="datetimeFigureOut">
              <a:rPr lang="en-US" smtClean="0"/>
              <a:t>1/2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3995E8-7E87-4611-A1FF-EF204549B9B1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81907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0B290C-3CC6-49F1-BA49-84934B59FCC5}" type="datetimeFigureOut">
              <a:rPr lang="en-US" smtClean="0"/>
              <a:t>1/2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3995E8-7E87-4611-A1FF-EF204549B9B1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87082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0B290C-3CC6-49F1-BA49-84934B59FCC5}" type="datetimeFigureOut">
              <a:rPr lang="en-US" smtClean="0"/>
              <a:t>1/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3995E8-7E87-4611-A1FF-EF204549B9B1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35662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 smtClean="0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0B290C-3CC6-49F1-BA49-84934B59FCC5}" type="datetimeFigureOut">
              <a:rPr lang="en-US" smtClean="0"/>
              <a:t>1/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3995E8-7E87-4611-A1FF-EF204549B9B1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46052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0B290C-3CC6-49F1-BA49-84934B59FCC5}" type="datetimeFigureOut">
              <a:rPr lang="en-US" smtClean="0"/>
              <a:t>1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3995E8-7E87-4611-A1FF-EF204549B9B1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47019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feld 4"/>
          <p:cNvSpPr txBox="1"/>
          <p:nvPr/>
        </p:nvSpPr>
        <p:spPr>
          <a:xfrm>
            <a:off x="940665" y="5629534"/>
            <a:ext cx="4863598" cy="8463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7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Patients in cohort 2 received various treatments before sampling: 33 allogeneic stem cell transplantation (5 receiving </a:t>
            </a:r>
            <a:r>
              <a:rPr lang="en-US" sz="7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zacytidine</a:t>
            </a:r>
            <a:r>
              <a:rPr lang="en-U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, chemotherapy, or </a:t>
            </a:r>
            <a:r>
              <a:rPr lang="en-US" sz="7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enalidomide</a:t>
            </a:r>
            <a:r>
              <a:rPr lang="en-U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 before transplantation), 18 </a:t>
            </a:r>
            <a:r>
              <a:rPr lang="en-US" sz="7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zacytidine</a:t>
            </a:r>
            <a:r>
              <a:rPr lang="en-U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, 12 chemotherapy (most </a:t>
            </a:r>
            <a:r>
              <a:rPr lang="en-US" sz="7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ydroxyurea</a:t>
            </a:r>
            <a:r>
              <a:rPr lang="en-U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 or </a:t>
            </a:r>
            <a:r>
              <a:rPr lang="en-US" sz="7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aunorubicin</a:t>
            </a:r>
            <a:r>
              <a:rPr lang="en-U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sz="7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ytarabine</a:t>
            </a:r>
            <a:r>
              <a:rPr lang="en-U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), 5 </a:t>
            </a:r>
            <a:r>
              <a:rPr lang="en-US" sz="7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uspatercept</a:t>
            </a:r>
            <a:r>
              <a:rPr lang="en-U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, 5 other </a:t>
            </a: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therapy </a:t>
            </a:r>
            <a:r>
              <a:rPr lang="en-U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(2 </a:t>
            </a:r>
            <a:r>
              <a:rPr lang="en-US" sz="7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anakinumab</a:t>
            </a: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1 </a:t>
            </a:r>
            <a:r>
              <a:rPr lang="en-US" sz="7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enalidomide</a:t>
            </a: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1 </a:t>
            </a:r>
            <a:r>
              <a:rPr lang="en-US" sz="7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uxolitinib</a:t>
            </a:r>
            <a:r>
              <a:rPr lang="en-U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, 1 </a:t>
            </a:r>
            <a:r>
              <a:rPr lang="en-US" sz="7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lthrombopaq</a:t>
            </a:r>
            <a:r>
              <a:rPr lang="en-U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). </a:t>
            </a:r>
            <a:r>
              <a:rPr lang="en-US" sz="7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nonMDS-cytopenias include: 5 CCUS, 19 ICUS,15 pts. with </a:t>
            </a: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normal </a:t>
            </a:r>
            <a:r>
              <a:rPr lang="en-U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cytogenetics/FISH (but missing mutational information). </a:t>
            </a:r>
            <a:r>
              <a:rPr lang="en-US" sz="7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IPSS-M was available for 59 / 65 patients diagnosed with MDS by WHO2022 classification. Abbreviations: pts., patients; n, number; NOS, not other specified; NCC, non-clonal </a:t>
            </a:r>
            <a:r>
              <a:rPr lang="en-US" sz="7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ytopenia</a:t>
            </a:r>
            <a:r>
              <a:rPr lang="en-U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; CR, complete remission; IPSS-M, International Prognostic Scoring System-molecular.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feld 1"/>
          <p:cNvSpPr txBox="1"/>
          <p:nvPr/>
        </p:nvSpPr>
        <p:spPr>
          <a:xfrm>
            <a:off x="914539" y="1820092"/>
            <a:ext cx="326884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Table 1 Patient characteristics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6" name="Tabelle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30392284"/>
              </p:ext>
            </p:extLst>
          </p:nvPr>
        </p:nvGraphicFramePr>
        <p:xfrm>
          <a:off x="1005980" y="2090588"/>
          <a:ext cx="4798283" cy="3538946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377175">
                  <a:extLst>
                    <a:ext uri="{9D8B030D-6E8A-4147-A177-3AD203B41FA5}">
                      <a16:colId xmlns:a16="http://schemas.microsoft.com/office/drawing/2014/main" val="2070463298"/>
                    </a:ext>
                  </a:extLst>
                </a:gridCol>
                <a:gridCol w="1417320">
                  <a:extLst>
                    <a:ext uri="{9D8B030D-6E8A-4147-A177-3AD203B41FA5}">
                      <a16:colId xmlns:a16="http://schemas.microsoft.com/office/drawing/2014/main" val="893371660"/>
                    </a:ext>
                  </a:extLst>
                </a:gridCol>
                <a:gridCol w="1019175">
                  <a:extLst>
                    <a:ext uri="{9D8B030D-6E8A-4147-A177-3AD203B41FA5}">
                      <a16:colId xmlns:a16="http://schemas.microsoft.com/office/drawing/2014/main" val="3285805347"/>
                    </a:ext>
                  </a:extLst>
                </a:gridCol>
                <a:gridCol w="984613">
                  <a:extLst>
                    <a:ext uri="{9D8B030D-6E8A-4147-A177-3AD203B41FA5}">
                      <a16:colId xmlns:a16="http://schemas.microsoft.com/office/drawing/2014/main" val="2107855762"/>
                    </a:ext>
                  </a:extLst>
                </a:gridCol>
              </a:tblGrid>
              <a:tr h="36000">
                <a:tc>
                  <a:txBody>
                    <a:bodyPr/>
                    <a:lstStyle/>
                    <a:p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1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Cohort 1</a:t>
                      </a:r>
                      <a:endParaRPr lang="en-US" sz="800" dirty="0" smtClean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GB" sz="800" b="1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(115 newly diagnosed patients with </a:t>
                      </a:r>
                      <a:r>
                        <a:rPr lang="en-GB" sz="800" b="1" kern="1200" dirty="0" err="1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cytopenias</a:t>
                      </a:r>
                      <a:r>
                        <a:rPr lang="en-GB" sz="800" b="1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)</a:t>
                      </a:r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8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hort 2</a:t>
                      </a:r>
                    </a:p>
                    <a:p>
                      <a:r>
                        <a:rPr lang="en-US" sz="8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74 treated MDS </a:t>
                      </a:r>
                      <a:r>
                        <a:rPr lang="en-US" sz="800" baseline="300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r>
                        <a:rPr lang="en-US" sz="8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8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ealthy blood donors (HD; 26)</a:t>
                      </a:r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6537730"/>
                  </a:ext>
                </a:extLst>
              </a:tr>
              <a:tr h="3600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 b="1" kern="100" dirty="0" smtClean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Age, </a:t>
                      </a:r>
                      <a:r>
                        <a:rPr lang="en-US" sz="800" b="0" kern="100" dirty="0" smtClean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median</a:t>
                      </a:r>
                      <a:r>
                        <a:rPr lang="en-US" sz="800" b="0" kern="100" baseline="0" dirty="0" smtClean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(</a:t>
                      </a:r>
                      <a:r>
                        <a:rPr lang="en-US" sz="800" b="0" kern="100" dirty="0" smtClean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range)</a:t>
                      </a:r>
                      <a:endParaRPr lang="en-US" sz="800" b="1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8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6 (18 – 85)</a:t>
                      </a:r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8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6 (44 – 83)</a:t>
                      </a:r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8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7 (42 – 82)</a:t>
                      </a:r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7881739"/>
                  </a:ext>
                </a:extLst>
              </a:tr>
              <a:tr h="36000">
                <a:tc gridSpan="3"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800" b="1" kern="1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s-ES" sz="800" b="1" kern="100" dirty="0" smtClean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Gender, </a:t>
                      </a:r>
                      <a:r>
                        <a:rPr lang="es-ES" sz="800" b="0" kern="100" dirty="0" smtClean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</a:t>
                      </a:r>
                      <a:endParaRPr lang="en-US" sz="800" b="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75" marR="3175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n-US" sz="800" b="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75" marR="3175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12725738"/>
                  </a:ext>
                </a:extLst>
              </a:tr>
              <a:tr h="36000">
                <a:tc>
                  <a:txBody>
                    <a:bodyPr/>
                    <a:lstStyle/>
                    <a:p>
                      <a:pPr lvl="0"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800" b="0" kern="100" dirty="0" smtClean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    male / female</a:t>
                      </a:r>
                      <a:endParaRPr lang="en-US" sz="800" b="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75" marR="3175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8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3 / 32</a:t>
                      </a:r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8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 / 24</a:t>
                      </a:r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8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 / 18</a:t>
                      </a:r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1693163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HO2022 diagnosis,</a:t>
                      </a:r>
                      <a:r>
                        <a:rPr lang="en-US" sz="800" b="1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800" b="0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 (%) </a:t>
                      </a:r>
                      <a:endParaRPr lang="en-US" sz="800" b="0" baseline="30000" dirty="0" smtClean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 marL="45720" marR="4572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45720" marR="4572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 marL="45720" marR="4572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70038241"/>
                  </a:ext>
                </a:extLst>
              </a:tr>
              <a:tr h="36000">
                <a:tc>
                  <a:txBody>
                    <a:bodyPr/>
                    <a:lstStyle/>
                    <a:p>
                      <a:pPr lvl="0"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800" b="0" kern="100" dirty="0" smtClean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    MDS-LB</a:t>
                      </a:r>
                      <a:endParaRPr lang="en-US" sz="800" b="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75" marR="3175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8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 (22)</a:t>
                      </a:r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8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 (15)</a:t>
                      </a:r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48039983"/>
                  </a:ext>
                </a:extLst>
              </a:tr>
              <a:tr h="36000">
                <a:tc>
                  <a:txBody>
                    <a:bodyPr/>
                    <a:lstStyle/>
                    <a:p>
                      <a:pPr lvl="0"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800" b="0" kern="100" dirty="0" smtClean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    MDS-</a:t>
                      </a:r>
                      <a:r>
                        <a:rPr lang="es-ES" sz="800" b="0" i="1" kern="100" dirty="0" smtClean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SF3B1</a:t>
                      </a:r>
                      <a:endParaRPr lang="en-US" sz="800" b="0" i="1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75" marR="3175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8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   (2)</a:t>
                      </a:r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8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   (4)</a:t>
                      </a:r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54093019"/>
                  </a:ext>
                </a:extLst>
              </a:tr>
              <a:tr h="36000">
                <a:tc>
                  <a:txBody>
                    <a:bodyPr/>
                    <a:lstStyle/>
                    <a:p>
                      <a:pPr lvl="0"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800" b="0" kern="100" dirty="0" smtClean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    MDS-IB1</a:t>
                      </a:r>
                      <a:endParaRPr lang="en-US" sz="800" b="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75" marR="3175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8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 (17)</a:t>
                      </a:r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8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   (11)</a:t>
                      </a:r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63388810"/>
                  </a:ext>
                </a:extLst>
              </a:tr>
              <a:tr h="36000">
                <a:tc>
                  <a:txBody>
                    <a:bodyPr/>
                    <a:lstStyle/>
                    <a:p>
                      <a:pPr lvl="0"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800" b="0" kern="100" dirty="0" smtClean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    MDS-IB2</a:t>
                      </a:r>
                      <a:endParaRPr lang="en-US" sz="800" b="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75" marR="3175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8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 (10)</a:t>
                      </a:r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8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 (15)</a:t>
                      </a:r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38619771"/>
                  </a:ext>
                </a:extLst>
              </a:tr>
              <a:tr h="36000">
                <a:tc>
                  <a:txBody>
                    <a:bodyPr/>
                    <a:lstStyle/>
                    <a:p>
                      <a:pPr lvl="0"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800" b="0" kern="100" dirty="0" smtClean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    MDS-5q</a:t>
                      </a:r>
                      <a:endParaRPr lang="en-US" sz="800" b="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75" marR="3175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8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   (1)</a:t>
                      </a:r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8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   (1)</a:t>
                      </a:r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85853586"/>
                  </a:ext>
                </a:extLst>
              </a:tr>
              <a:tr h="36000">
                <a:tc>
                  <a:txBody>
                    <a:bodyPr/>
                    <a:lstStyle/>
                    <a:p>
                      <a:pPr lvl="0"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 b="0" kern="100" dirty="0" smtClean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    MDS-bi</a:t>
                      </a:r>
                      <a:r>
                        <a:rPr lang="en-US" sz="800" b="0" i="1" kern="100" dirty="0" smtClean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TP53</a:t>
                      </a:r>
                      <a:endParaRPr lang="en-US" sz="800" b="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75" marR="3175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8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   (1)</a:t>
                      </a:r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8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77644048"/>
                  </a:ext>
                </a:extLst>
              </a:tr>
              <a:tr h="36000">
                <a:tc>
                  <a:txBody>
                    <a:bodyPr/>
                    <a:lstStyle/>
                    <a:p>
                      <a:pPr lvl="0"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800" b="0" kern="100" dirty="0" smtClean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    CMML-1</a:t>
                      </a:r>
                      <a:endParaRPr lang="en-US" sz="800" b="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75" marR="3175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8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   (8)</a:t>
                      </a:r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8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   (7)</a:t>
                      </a:r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24152831"/>
                  </a:ext>
                </a:extLst>
              </a:tr>
              <a:tr h="36000">
                <a:tc>
                  <a:txBody>
                    <a:bodyPr/>
                    <a:lstStyle/>
                    <a:p>
                      <a:pPr lvl="0"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800" b="0" kern="100" dirty="0" smtClean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    CMML-2</a:t>
                      </a:r>
                      <a:endParaRPr lang="en-US" sz="800" b="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75" marR="3175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8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   (2)</a:t>
                      </a:r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8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   (5)</a:t>
                      </a:r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58523002"/>
                  </a:ext>
                </a:extLst>
              </a:tr>
              <a:tr h="288000">
                <a:tc>
                  <a:txBody>
                    <a:bodyPr/>
                    <a:lstStyle/>
                    <a:p>
                      <a:pPr lvl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800" b="0" kern="100" dirty="0" smtClean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   MDS/MPN </a:t>
                      </a:r>
                      <a:r>
                        <a:rPr lang="en-GB" sz="800" b="0" kern="1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with </a:t>
                      </a:r>
                      <a:r>
                        <a:rPr lang="en-GB" sz="800" b="0" i="1" kern="1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SF3B1</a:t>
                      </a:r>
                      <a:r>
                        <a:rPr lang="en-GB" sz="800" b="0" kern="1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GB" sz="800" b="0" kern="100" dirty="0" smtClean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</a:t>
                      </a:r>
                    </a:p>
                    <a:p>
                      <a:pPr lvl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800" b="0" kern="100" baseline="0" dirty="0" smtClean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   </a:t>
                      </a:r>
                      <a:r>
                        <a:rPr lang="en-GB" sz="800" b="0" kern="100" dirty="0" smtClean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nd</a:t>
                      </a:r>
                      <a:r>
                        <a:rPr lang="en-GB" sz="800" b="0" kern="100" baseline="0" dirty="0" smtClean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GB" sz="800" b="0" kern="100" dirty="0" smtClean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thrombocytosis</a:t>
                      </a:r>
                      <a:endParaRPr lang="en-US" sz="800" b="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8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8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   (1)</a:t>
                      </a:r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1980966"/>
                  </a:ext>
                </a:extLst>
              </a:tr>
              <a:tr h="36000">
                <a:tc>
                  <a:txBody>
                    <a:bodyPr/>
                    <a:lstStyle/>
                    <a:p>
                      <a:pPr lvl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 b="0" kern="100" dirty="0" smtClean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    MDS/MPN-NOS</a:t>
                      </a:r>
                      <a:endParaRPr lang="en-US" sz="800" b="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75" marR="3175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8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   (3)</a:t>
                      </a:r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8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   (4)</a:t>
                      </a:r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87626008"/>
                  </a:ext>
                </a:extLst>
              </a:tr>
              <a:tr h="36000">
                <a:tc>
                  <a:txBody>
                    <a:bodyPr/>
                    <a:lstStyle/>
                    <a:p>
                      <a:pPr lvl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 b="0" kern="1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    nonMDS-cytopenias</a:t>
                      </a:r>
                      <a:r>
                        <a:rPr lang="en-US" sz="800" b="0" kern="100" baseline="300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n-US" sz="800" b="0" kern="100" baseline="300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75" marR="3175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8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9</a:t>
                      </a:r>
                      <a:r>
                        <a:rPr lang="en-US" sz="8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34)</a:t>
                      </a:r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−</a:t>
                      </a:r>
                    </a:p>
                  </a:txBody>
                  <a:tcPr marL="45720" marR="4572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800" dirty="0" smtClean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89891512"/>
                  </a:ext>
                </a:extLst>
              </a:tr>
              <a:tr h="36000">
                <a:tc>
                  <a:txBody>
                    <a:bodyPr/>
                    <a:lstStyle/>
                    <a:p>
                      <a:pPr lvl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 b="0" kern="1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    CR-MDS</a:t>
                      </a:r>
                      <a:endParaRPr lang="en-US" sz="80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75" marR="3175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−</a:t>
                      </a:r>
                    </a:p>
                  </a:txBody>
                  <a:tcPr marL="45720" marR="4572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­­</a:t>
                      </a:r>
                      <a:r>
                        <a:rPr lang="en-US" sz="8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 (37)</a:t>
                      </a:r>
                    </a:p>
                  </a:txBody>
                  <a:tcPr marL="45720" marR="4572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800" dirty="0" smtClean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29531601"/>
                  </a:ext>
                </a:extLst>
              </a:tr>
              <a:tr h="108000">
                <a:tc gridSpan="3"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PSS-M,</a:t>
                      </a:r>
                      <a:r>
                        <a:rPr lang="en-US" sz="800" b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n</a:t>
                      </a:r>
                      <a:r>
                        <a:rPr lang="en-US" sz="800" b="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</a:t>
                      </a:r>
                      <a:r>
                        <a:rPr lang="en-US" sz="800" b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%)</a:t>
                      </a:r>
                      <a:r>
                        <a:rPr lang="en-US" sz="800" b="0" baseline="30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en-US" sz="800" b="1" baseline="30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800" b="1" baseline="30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8563017"/>
                  </a:ext>
                </a:extLst>
              </a:tr>
              <a:tr h="108000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very low</a:t>
                      </a:r>
                      <a:endParaRPr lang="en-US" sz="8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   (3)</a:t>
                      </a:r>
                    </a:p>
                  </a:txBody>
                  <a:tcPr marL="45720" marR="4572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en-US" sz="800" dirty="0"/>
                    </a:p>
                  </a:txBody>
                  <a:tcPr marL="45720" marR="4572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25503429"/>
                  </a:ext>
                </a:extLst>
              </a:tr>
              <a:tr h="108000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low</a:t>
                      </a:r>
                      <a:endParaRPr lang="en-US" sz="8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 (24)</a:t>
                      </a:r>
                    </a:p>
                  </a:txBody>
                  <a:tcPr marL="45720" marR="4572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en-US" sz="800"/>
                    </a:p>
                  </a:txBody>
                  <a:tcPr marL="45720" marR="4572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83677696"/>
                  </a:ext>
                </a:extLst>
              </a:tr>
              <a:tr h="108000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moderate low</a:t>
                      </a:r>
                      <a:endParaRPr lang="en-US" sz="8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   (15)</a:t>
                      </a:r>
                    </a:p>
                  </a:txBody>
                  <a:tcPr marL="45720" marR="4572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en-US" sz="800"/>
                    </a:p>
                  </a:txBody>
                  <a:tcPr marL="45720" marR="4572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40590022"/>
                  </a:ext>
                </a:extLst>
              </a:tr>
              <a:tr h="108000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moderate high</a:t>
                      </a:r>
                      <a:endParaRPr lang="en-US" sz="8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   (14)</a:t>
                      </a:r>
                    </a:p>
                  </a:txBody>
                  <a:tcPr marL="45720" marR="4572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en-US" sz="800"/>
                    </a:p>
                  </a:txBody>
                  <a:tcPr marL="45720" marR="4572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64081041"/>
                  </a:ext>
                </a:extLst>
              </a:tr>
              <a:tr h="108000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high</a:t>
                      </a:r>
                      <a:endParaRPr lang="en-US" sz="8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 (30)</a:t>
                      </a:r>
                    </a:p>
                  </a:txBody>
                  <a:tcPr marL="45720" marR="4572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en-US" sz="800"/>
                    </a:p>
                  </a:txBody>
                  <a:tcPr marL="45720" marR="4572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07727645"/>
                  </a:ext>
                </a:extLst>
              </a:tr>
              <a:tr h="108000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very high</a:t>
                      </a:r>
                      <a:endParaRPr lang="en-US" sz="8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   (14)</a:t>
                      </a:r>
                    </a:p>
                  </a:txBody>
                  <a:tcPr marL="45720" marR="4572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en-US" sz="800"/>
                    </a:p>
                  </a:txBody>
                  <a:tcPr marL="45720" marR="4572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23613599"/>
                  </a:ext>
                </a:extLst>
              </a:tr>
            </a:tbl>
          </a:graphicData>
        </a:graphic>
      </p:graphicFrame>
      <p:sp>
        <p:nvSpPr>
          <p:cNvPr id="10" name="Textfeld 9"/>
          <p:cNvSpPr txBox="1"/>
          <p:nvPr/>
        </p:nvSpPr>
        <p:spPr>
          <a:xfrm>
            <a:off x="914539" y="258436"/>
            <a:ext cx="5616889" cy="7540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Bef>
                <a:spcPts val="600"/>
              </a:spcBef>
              <a:spcAft>
                <a:spcPts val="600"/>
              </a:spcAft>
            </a:pP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Information to </a:t>
            </a:r>
          </a:p>
          <a:p>
            <a:pPr>
              <a:spcBef>
                <a:spcPts val="600"/>
              </a:spcBef>
              <a:spcAft>
                <a:spcPts val="600"/>
              </a:spcAft>
            </a:pP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MDS-PB13 Score - Blood based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detection of aberrancies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by flow cytometry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in patients with suspected and confirmed Myelodysplastic Neoplasms</a:t>
            </a:r>
          </a:p>
        </p:txBody>
      </p:sp>
    </p:spTree>
    <p:extLst>
      <p:ext uri="{BB962C8B-B14F-4D97-AF65-F5344CB8AC3E}">
        <p14:creationId xmlns:p14="http://schemas.microsoft.com/office/powerpoint/2010/main" val="429059999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feld 4"/>
          <p:cNvSpPr txBox="1"/>
          <p:nvPr/>
        </p:nvSpPr>
        <p:spPr>
          <a:xfrm>
            <a:off x="1004817" y="3931777"/>
            <a:ext cx="2645409" cy="548727"/>
          </a:xfrm>
          <a:prstGeom prst="rect">
            <a:avLst/>
          </a:prstGeom>
          <a:noFill/>
        </p:spPr>
        <p:txBody>
          <a:bodyPr wrap="square" lIns="20250" tIns="20250" rIns="20250" bIns="20250" rtlCol="0">
            <a:spAutoFit/>
          </a:bodyPr>
          <a:lstStyle/>
          <a:p>
            <a:pPr algn="just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Table 3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MDS diagnosis by FCM in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patients inappropriate BM </a:t>
            </a:r>
            <a:r>
              <a:rPr lang="en-US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cytomorphology</a:t>
            </a:r>
            <a:endParaRPr lang="en-US" sz="11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1" name="Tabelle 1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01006441"/>
              </p:ext>
            </p:extLst>
          </p:nvPr>
        </p:nvGraphicFramePr>
        <p:xfrm>
          <a:off x="1004817" y="4510859"/>
          <a:ext cx="2815015" cy="2421255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657005">
                  <a:extLst>
                    <a:ext uri="{9D8B030D-6E8A-4147-A177-3AD203B41FA5}">
                      <a16:colId xmlns:a16="http://schemas.microsoft.com/office/drawing/2014/main" val="2070463298"/>
                    </a:ext>
                  </a:extLst>
                </a:gridCol>
                <a:gridCol w="978139">
                  <a:extLst>
                    <a:ext uri="{9D8B030D-6E8A-4147-A177-3AD203B41FA5}">
                      <a16:colId xmlns:a16="http://schemas.microsoft.com/office/drawing/2014/main" val="2638171010"/>
                    </a:ext>
                  </a:extLst>
                </a:gridCol>
                <a:gridCol w="589936">
                  <a:extLst>
                    <a:ext uri="{9D8B030D-6E8A-4147-A177-3AD203B41FA5}">
                      <a16:colId xmlns:a16="http://schemas.microsoft.com/office/drawing/2014/main" val="4275151926"/>
                    </a:ext>
                  </a:extLst>
                </a:gridCol>
                <a:gridCol w="589935">
                  <a:extLst>
                    <a:ext uri="{9D8B030D-6E8A-4147-A177-3AD203B41FA5}">
                      <a16:colId xmlns:a16="http://schemas.microsoft.com/office/drawing/2014/main" val="3929370862"/>
                    </a:ext>
                  </a:extLst>
                </a:gridCol>
              </a:tblGrid>
              <a:tr h="154305">
                <a:tc>
                  <a:txBody>
                    <a:bodyPr/>
                    <a:lstStyle/>
                    <a:p>
                      <a:r>
                        <a:rPr lang="en-US" sz="8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hort 1</a:t>
                      </a:r>
                      <a:endParaRPr lang="en-US" sz="8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718" marR="25718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8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HO2022</a:t>
                      </a:r>
                      <a:r>
                        <a:rPr lang="en-US" sz="800" b="0" baseline="300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800" b="0" baseline="300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718" marR="25718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8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CM in BM</a:t>
                      </a:r>
                      <a:endParaRPr lang="en-US" sz="8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718" marR="25718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8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DS-PB13</a:t>
                      </a:r>
                      <a:endParaRPr lang="en-US" sz="8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718" marR="25718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6537730"/>
                  </a:ext>
                </a:extLst>
              </a:tr>
              <a:tr h="154305">
                <a:tc>
                  <a:txBody>
                    <a:bodyPr/>
                    <a:lstStyle/>
                    <a:p>
                      <a:r>
                        <a:rPr lang="en-US" sz="800" i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tient 1_1</a:t>
                      </a:r>
                      <a:endParaRPr lang="en-US" sz="800" i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718" marR="25718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800" b="0" i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DS/MPN-NOS</a:t>
                      </a:r>
                      <a:endParaRPr lang="en-US" sz="800" b="0" i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718" marR="25718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800" b="0" i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DS</a:t>
                      </a:r>
                      <a:endParaRPr lang="en-US" sz="800" b="0" i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718" marR="25718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8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DS</a:t>
                      </a:r>
                      <a:endParaRPr lang="en-US" sz="8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718" marR="25718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17444484"/>
                  </a:ext>
                </a:extLst>
              </a:tr>
              <a:tr h="77153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i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tient 1_2</a:t>
                      </a:r>
                    </a:p>
                  </a:txBody>
                  <a:tcPr marL="25718" marR="25718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800" b="0" i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DS-IB2</a:t>
                      </a:r>
                      <a:endParaRPr lang="en-US" sz="800" b="0" i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718" marR="25718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800" b="0" i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DS</a:t>
                      </a:r>
                      <a:endParaRPr lang="en-US" sz="800" b="0" i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718" marR="25718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DS</a:t>
                      </a:r>
                    </a:p>
                  </a:txBody>
                  <a:tcPr marL="25718" marR="25718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71391339"/>
                  </a:ext>
                </a:extLst>
              </a:tr>
              <a:tr h="154305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i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tient 1_3</a:t>
                      </a:r>
                    </a:p>
                  </a:txBody>
                  <a:tcPr marL="25718" marR="25718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800" b="0" i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DS-IB1</a:t>
                      </a:r>
                      <a:endParaRPr lang="en-US" sz="800" b="0" i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718" marR="25718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800" b="0" i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DS</a:t>
                      </a:r>
                      <a:endParaRPr lang="en-US" sz="800" b="0" i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718" marR="25718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DS</a:t>
                      </a:r>
                    </a:p>
                  </a:txBody>
                  <a:tcPr marL="25718" marR="25718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11271075"/>
                  </a:ext>
                </a:extLst>
              </a:tr>
              <a:tr h="77153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i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tient 1_4</a:t>
                      </a:r>
                    </a:p>
                  </a:txBody>
                  <a:tcPr marL="25718" marR="25718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800" b="0" i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DS-LB</a:t>
                      </a:r>
                      <a:endParaRPr lang="en-US" sz="800" b="0" i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718" marR="25718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800" b="0" i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DS</a:t>
                      </a:r>
                      <a:endParaRPr lang="en-US" sz="800" b="0" i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718" marR="25718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8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 MDS</a:t>
                      </a:r>
                      <a:endParaRPr lang="en-US" sz="8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718" marR="25718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54951442"/>
                  </a:ext>
                </a:extLst>
              </a:tr>
              <a:tr h="77153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i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tient 1_5</a:t>
                      </a:r>
                    </a:p>
                  </a:txBody>
                  <a:tcPr marL="25718" marR="25718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800" b="0" i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DS-LB</a:t>
                      </a:r>
                      <a:endParaRPr lang="en-US" sz="800" b="0" i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718" marR="25718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800" b="0" i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DS</a:t>
                      </a:r>
                      <a:endParaRPr lang="en-US" sz="800" b="0" i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718" marR="25718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 MDS</a:t>
                      </a:r>
                    </a:p>
                  </a:txBody>
                  <a:tcPr marL="25718" marR="25718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47974305"/>
                  </a:ext>
                </a:extLst>
              </a:tr>
              <a:tr h="154305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i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tient 1_6</a:t>
                      </a:r>
                    </a:p>
                  </a:txBody>
                  <a:tcPr marL="25718" marR="25718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800" b="0" i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DS-LB</a:t>
                      </a:r>
                      <a:endParaRPr lang="en-US" sz="800" b="0" i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718" marR="25718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800" b="0" i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DS</a:t>
                      </a:r>
                      <a:endParaRPr lang="en-US" sz="800" b="0" i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718" marR="25718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DS</a:t>
                      </a:r>
                    </a:p>
                  </a:txBody>
                  <a:tcPr marL="25718" marR="25718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99840714"/>
                  </a:ext>
                </a:extLst>
              </a:tr>
              <a:tr h="77153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i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tient 1_7</a:t>
                      </a:r>
                    </a:p>
                  </a:txBody>
                  <a:tcPr marL="25718" marR="25718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800" b="0" i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DS-IB1</a:t>
                      </a:r>
                      <a:endParaRPr lang="en-US" sz="800" b="0" i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718" marR="25718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800" b="0" i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DS</a:t>
                      </a:r>
                      <a:endParaRPr lang="en-US" sz="800" b="0" i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718" marR="25718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8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DS</a:t>
                      </a:r>
                      <a:endParaRPr lang="en-US" sz="8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718" marR="25718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5846173"/>
                  </a:ext>
                </a:extLst>
              </a:tr>
              <a:tr h="77153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i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tient 1_8</a:t>
                      </a:r>
                    </a:p>
                  </a:txBody>
                  <a:tcPr marL="25718" marR="25718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800" b="0" i="0" dirty="0" err="1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nMDS-cytopenia</a:t>
                      </a:r>
                      <a:endParaRPr lang="en-US" sz="800" b="0" i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718" marR="25718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800" b="0" i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DS</a:t>
                      </a:r>
                      <a:endParaRPr lang="en-US" sz="800" b="0" i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718" marR="25718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 MDS</a:t>
                      </a:r>
                    </a:p>
                  </a:txBody>
                  <a:tcPr marL="25718" marR="25718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68610737"/>
                  </a:ext>
                </a:extLst>
              </a:tr>
              <a:tr h="154305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i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tient 1_9</a:t>
                      </a:r>
                    </a:p>
                  </a:txBody>
                  <a:tcPr marL="25718" marR="25718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800" b="0" i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DS/MPN-NOS</a:t>
                      </a:r>
                      <a:endParaRPr lang="en-US" sz="800" b="0" i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718" marR="25718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800" b="0" i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DS</a:t>
                      </a:r>
                      <a:endParaRPr lang="en-US" sz="800" b="0" i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718" marR="25718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DS</a:t>
                      </a:r>
                    </a:p>
                  </a:txBody>
                  <a:tcPr marL="25718" marR="25718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91698821"/>
                  </a:ext>
                </a:extLst>
              </a:tr>
              <a:tr h="154305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i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tient 1_10</a:t>
                      </a:r>
                    </a:p>
                  </a:txBody>
                  <a:tcPr marL="25718" marR="25718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800" b="0" i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DS/MPN-NOS</a:t>
                      </a:r>
                      <a:endParaRPr lang="en-US" sz="800" b="0" i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718" marR="25718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800" b="0" i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DS</a:t>
                      </a:r>
                      <a:endParaRPr lang="en-US" sz="800" b="0" i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718" marR="25718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8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DS</a:t>
                      </a:r>
                      <a:endParaRPr lang="en-US" sz="8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718" marR="25718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73040229"/>
                  </a:ext>
                </a:extLst>
              </a:tr>
              <a:tr h="77153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i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tient 1_11</a:t>
                      </a:r>
                    </a:p>
                  </a:txBody>
                  <a:tcPr marL="25718" marR="25718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800" b="0" i="0" dirty="0" err="1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nMDS-cytopenia</a:t>
                      </a:r>
                      <a:endParaRPr lang="en-US" sz="800" b="0" i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718" marR="25718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800" b="0" i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 MDS</a:t>
                      </a:r>
                      <a:endParaRPr lang="en-US" sz="800" b="0" i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718" marR="25718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 MDS</a:t>
                      </a:r>
                    </a:p>
                  </a:txBody>
                  <a:tcPr marL="25718" marR="25718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62691555"/>
                  </a:ext>
                </a:extLst>
              </a:tr>
              <a:tr h="77153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i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tient 1_12</a:t>
                      </a:r>
                    </a:p>
                  </a:txBody>
                  <a:tcPr marL="25718" marR="25718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800" b="0" i="0" dirty="0" err="1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nMDS-cytopenia</a:t>
                      </a:r>
                      <a:endParaRPr lang="en-US" sz="800" b="0" i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718" marR="25718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800" b="0" i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 MDS</a:t>
                      </a:r>
                      <a:endParaRPr lang="en-US" sz="800" b="0" i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718" marR="25718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 MDS</a:t>
                      </a:r>
                    </a:p>
                  </a:txBody>
                  <a:tcPr marL="25718" marR="25718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50339976"/>
                  </a:ext>
                </a:extLst>
              </a:tr>
              <a:tr h="77153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1" i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hort 2</a:t>
                      </a:r>
                    </a:p>
                  </a:txBody>
                  <a:tcPr marL="25718" marR="25718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en-US" sz="800" b="0" i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718" marR="25718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en-US" sz="800" b="0" i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718" marR="25718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800" b="0" i="0" dirty="0" smtClean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718" marR="25718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67403783"/>
                  </a:ext>
                </a:extLst>
              </a:tr>
              <a:tr h="77153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i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tient 2_1</a:t>
                      </a:r>
                    </a:p>
                  </a:txBody>
                  <a:tcPr marL="25718" marR="25718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800" b="0" i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MML-1</a:t>
                      </a:r>
                      <a:endParaRPr lang="en-US" sz="800" b="0" i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718" marR="25718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800" b="0" i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DS</a:t>
                      </a:r>
                      <a:endParaRPr lang="en-US" sz="800" b="0" i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718" marR="25718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DS</a:t>
                      </a:r>
                    </a:p>
                  </a:txBody>
                  <a:tcPr marL="25718" marR="25718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10569042"/>
                  </a:ext>
                </a:extLst>
              </a:tr>
              <a:tr h="154305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i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tient 2_2</a:t>
                      </a:r>
                    </a:p>
                  </a:txBody>
                  <a:tcPr marL="25718" marR="25718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800" b="0" i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DS/MPN-NOS</a:t>
                      </a:r>
                      <a:endParaRPr lang="en-US" sz="800" b="0" i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718" marR="25718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800" b="0" i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DS</a:t>
                      </a:r>
                      <a:endParaRPr lang="en-US" sz="800" b="0" i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718" marR="25718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800" b="0" i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DS</a:t>
                      </a:r>
                      <a:endParaRPr lang="en-US" sz="800" b="0" i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718" marR="25718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8944226"/>
                  </a:ext>
                </a:extLst>
              </a:tr>
              <a:tr h="77153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i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tient 2_3</a:t>
                      </a:r>
                    </a:p>
                  </a:txBody>
                  <a:tcPr marL="25718" marR="25718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800" b="0" i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DS/MPN-NOS</a:t>
                      </a:r>
                      <a:endParaRPr lang="en-US" sz="800" b="0" i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718" marR="25718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800" b="0" i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 MDS</a:t>
                      </a:r>
                      <a:endParaRPr lang="en-US" sz="800" b="0" i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718" marR="25718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 MDS</a:t>
                      </a:r>
                    </a:p>
                  </a:txBody>
                  <a:tcPr marL="25718" marR="25718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44104152"/>
                  </a:ext>
                </a:extLst>
              </a:tr>
              <a:tr h="77153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i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tient</a:t>
                      </a:r>
                      <a:r>
                        <a:rPr lang="en-US" sz="800" i="0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2_4</a:t>
                      </a:r>
                      <a:endParaRPr lang="en-US" sz="800" i="0" dirty="0" smtClean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718" marR="25718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800" b="0" i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MML-2</a:t>
                      </a:r>
                      <a:endParaRPr lang="en-US" sz="800" b="0" i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718" marR="25718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800" b="0" i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 MDS</a:t>
                      </a:r>
                      <a:endParaRPr lang="en-US" sz="800" b="0" i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5718" marR="25718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 MDS</a:t>
                      </a:r>
                    </a:p>
                  </a:txBody>
                  <a:tcPr marL="25718" marR="25718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12374758"/>
                  </a:ext>
                </a:extLst>
              </a:tr>
            </a:tbl>
          </a:graphicData>
        </a:graphic>
      </p:graphicFrame>
      <p:graphicFrame>
        <p:nvGraphicFramePr>
          <p:cNvPr id="6" name="Tabelle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7647284"/>
              </p:ext>
            </p:extLst>
          </p:nvPr>
        </p:nvGraphicFramePr>
        <p:xfrm>
          <a:off x="1004818" y="1053513"/>
          <a:ext cx="2645408" cy="170784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141072">
                  <a:extLst>
                    <a:ext uri="{9D8B030D-6E8A-4147-A177-3AD203B41FA5}">
                      <a16:colId xmlns:a16="http://schemas.microsoft.com/office/drawing/2014/main" val="1661640757"/>
                    </a:ext>
                  </a:extLst>
                </a:gridCol>
                <a:gridCol w="737420">
                  <a:extLst>
                    <a:ext uri="{9D8B030D-6E8A-4147-A177-3AD203B41FA5}">
                      <a16:colId xmlns:a16="http://schemas.microsoft.com/office/drawing/2014/main" val="176137052"/>
                    </a:ext>
                  </a:extLst>
                </a:gridCol>
                <a:gridCol w="766916">
                  <a:extLst>
                    <a:ext uri="{9D8B030D-6E8A-4147-A177-3AD203B41FA5}">
                      <a16:colId xmlns:a16="http://schemas.microsoft.com/office/drawing/2014/main" val="1443579197"/>
                    </a:ext>
                  </a:extLst>
                </a:gridCol>
              </a:tblGrid>
              <a:tr h="122400">
                <a:tc>
                  <a:txBody>
                    <a:bodyPr/>
                    <a:lstStyle/>
                    <a:p>
                      <a:r>
                        <a:rPr lang="en-US" sz="8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hort 1</a:t>
                      </a:r>
                      <a:r>
                        <a:rPr lang="en-US" sz="8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adapted)</a:t>
                      </a:r>
                      <a:r>
                        <a:rPr lang="en-US" sz="800" b="0" baseline="300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800" b="1" baseline="30000" dirty="0" smtClean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8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70 patients)</a:t>
                      </a:r>
                      <a:endParaRPr lang="en-US" sz="8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8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berrant</a:t>
                      </a:r>
                      <a:r>
                        <a:rPr lang="en-US" sz="800" b="0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800" b="0" dirty="0" err="1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yPC</a:t>
                      </a:r>
                      <a:r>
                        <a:rPr lang="en-US" sz="8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BM)</a:t>
                      </a:r>
                      <a:endParaRPr lang="en-US" sz="8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8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/o</a:t>
                      </a:r>
                      <a:r>
                        <a:rPr lang="en-US" sz="800" b="0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8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berrant </a:t>
                      </a:r>
                      <a:r>
                        <a:rPr lang="en-US" sz="800" b="0" dirty="0" err="1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yPC</a:t>
                      </a:r>
                      <a:r>
                        <a:rPr lang="en-US" sz="8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BM)</a:t>
                      </a:r>
                      <a:endParaRPr lang="en-US" sz="8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2609128"/>
                  </a:ext>
                </a:extLst>
              </a:tr>
              <a:tr h="122400">
                <a:tc>
                  <a:txBody>
                    <a:bodyPr/>
                    <a:lstStyle/>
                    <a:p>
                      <a:r>
                        <a:rPr lang="en-US" sz="8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berrant </a:t>
                      </a:r>
                      <a:r>
                        <a:rPr lang="en-US" sz="800" b="0" dirty="0" err="1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yPC</a:t>
                      </a:r>
                      <a:r>
                        <a:rPr lang="en-US" sz="800" b="0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</a:p>
                    <a:p>
                      <a:r>
                        <a:rPr lang="en-US" sz="800" b="0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blood)</a:t>
                      </a:r>
                      <a:endParaRPr lang="en-US" sz="8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8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7%</a:t>
                      </a:r>
                      <a:endParaRPr lang="en-US" sz="8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8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%</a:t>
                      </a:r>
                      <a:endParaRPr lang="en-US" sz="8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98888357"/>
                  </a:ext>
                </a:extLst>
              </a:tr>
              <a:tr h="122400">
                <a:tc>
                  <a:txBody>
                    <a:bodyPr/>
                    <a:lstStyle/>
                    <a:p>
                      <a:r>
                        <a:rPr lang="en-US" sz="8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/o</a:t>
                      </a:r>
                      <a:r>
                        <a:rPr lang="en-US" sz="800" b="0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8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berrant </a:t>
                      </a:r>
                      <a:r>
                        <a:rPr lang="en-US" sz="800" b="0" dirty="0" err="1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yPC</a:t>
                      </a:r>
                      <a:r>
                        <a:rPr lang="en-US" sz="8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blood)</a:t>
                      </a:r>
                      <a:endParaRPr lang="en-US" sz="8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8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%</a:t>
                      </a:r>
                      <a:endParaRPr lang="en-US" sz="8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8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%</a:t>
                      </a:r>
                      <a:endParaRPr lang="en-US" sz="8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95506144"/>
                  </a:ext>
                </a:extLst>
              </a:tr>
              <a:tr h="122400">
                <a:tc>
                  <a:txBody>
                    <a:bodyPr/>
                    <a:lstStyle/>
                    <a:p>
                      <a:r>
                        <a:rPr lang="en-US" sz="8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ncordance</a:t>
                      </a:r>
                      <a:endParaRPr lang="en-US" sz="8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8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6%</a:t>
                      </a:r>
                      <a:endParaRPr lang="en-US" sz="8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32156422"/>
                  </a:ext>
                </a:extLst>
              </a:tr>
              <a:tr h="122400">
                <a:tc>
                  <a:txBody>
                    <a:bodyPr/>
                    <a:lstStyle/>
                    <a:p>
                      <a:r>
                        <a:rPr lang="en-US" sz="8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hort 2</a:t>
                      </a:r>
                      <a:r>
                        <a:rPr lang="en-US" sz="8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adapted)</a:t>
                      </a:r>
                      <a:r>
                        <a:rPr lang="en-US" sz="800" b="0" baseline="300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800" b="1" baseline="30000" dirty="0" smtClean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8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41 patients)</a:t>
                      </a:r>
                      <a:endParaRPr lang="en-US" sz="8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8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berrant</a:t>
                      </a:r>
                      <a:r>
                        <a:rPr lang="en-US" sz="800" b="0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800" b="0" dirty="0" err="1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yPC</a:t>
                      </a:r>
                      <a:r>
                        <a:rPr lang="en-US" sz="8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BM)</a:t>
                      </a:r>
                      <a:endParaRPr lang="en-US" sz="8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8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/o</a:t>
                      </a:r>
                      <a:r>
                        <a:rPr lang="en-US" sz="800" b="0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8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berrant </a:t>
                      </a:r>
                      <a:r>
                        <a:rPr lang="en-US" sz="800" b="0" dirty="0" err="1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yPC</a:t>
                      </a:r>
                      <a:r>
                        <a:rPr lang="en-US" sz="8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BM)</a:t>
                      </a:r>
                      <a:endParaRPr lang="en-US" sz="8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42046233"/>
                  </a:ext>
                </a:extLst>
              </a:tr>
              <a:tr h="122400">
                <a:tc>
                  <a:txBody>
                    <a:bodyPr/>
                    <a:lstStyle/>
                    <a:p>
                      <a:r>
                        <a:rPr lang="en-US" sz="8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berrant </a:t>
                      </a:r>
                      <a:r>
                        <a:rPr lang="en-US" sz="800" b="0" dirty="0" err="1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yPC</a:t>
                      </a:r>
                      <a:r>
                        <a:rPr lang="en-US" sz="800" b="0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</a:p>
                    <a:p>
                      <a:r>
                        <a:rPr lang="en-US" sz="800" b="0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blood)</a:t>
                      </a:r>
                      <a:endParaRPr lang="en-US" sz="8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8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6%</a:t>
                      </a:r>
                      <a:endParaRPr lang="en-US" sz="8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8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%</a:t>
                      </a:r>
                      <a:endParaRPr lang="en-US" sz="8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95908374"/>
                  </a:ext>
                </a:extLst>
              </a:tr>
              <a:tr h="122400">
                <a:tc>
                  <a:txBody>
                    <a:bodyPr/>
                    <a:lstStyle/>
                    <a:p>
                      <a:r>
                        <a:rPr lang="en-US" sz="8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/o</a:t>
                      </a:r>
                      <a:r>
                        <a:rPr lang="en-US" sz="800" b="0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8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berrant </a:t>
                      </a:r>
                      <a:r>
                        <a:rPr lang="en-US" sz="800" b="0" dirty="0" err="1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yPC</a:t>
                      </a:r>
                      <a:r>
                        <a:rPr lang="en-US" sz="8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blood)</a:t>
                      </a:r>
                      <a:endParaRPr lang="en-US" sz="8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8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%</a:t>
                      </a:r>
                      <a:endParaRPr lang="en-US" sz="8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8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%</a:t>
                      </a:r>
                      <a:endParaRPr lang="en-US" sz="8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74316706"/>
                  </a:ext>
                </a:extLst>
              </a:tr>
              <a:tr h="122400">
                <a:tc>
                  <a:txBody>
                    <a:bodyPr/>
                    <a:lstStyle/>
                    <a:p>
                      <a:r>
                        <a:rPr lang="en-US" sz="8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ncordance</a:t>
                      </a:r>
                      <a:endParaRPr lang="en-US" sz="8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8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0%</a:t>
                      </a:r>
                      <a:endParaRPr lang="en-US" sz="8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46947326"/>
                  </a:ext>
                </a:extLst>
              </a:tr>
            </a:tbl>
          </a:graphicData>
        </a:graphic>
      </p:graphicFrame>
      <p:sp>
        <p:nvSpPr>
          <p:cNvPr id="7" name="Textfeld 6"/>
          <p:cNvSpPr txBox="1"/>
          <p:nvPr/>
        </p:nvSpPr>
        <p:spPr>
          <a:xfrm>
            <a:off x="1004818" y="324030"/>
            <a:ext cx="2645408" cy="718004"/>
          </a:xfrm>
          <a:prstGeom prst="rect">
            <a:avLst/>
          </a:prstGeom>
          <a:noFill/>
        </p:spPr>
        <p:txBody>
          <a:bodyPr wrap="square" lIns="20250" tIns="20250" rIns="20250" bIns="20250" rtlCol="0">
            <a:spAutoFit/>
          </a:bodyPr>
          <a:lstStyle/>
          <a:p>
            <a:pPr algn="just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Table 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 Concordance of detecting FCM aberrancies in </a:t>
            </a:r>
            <a:r>
              <a:rPr lang="en-US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yPC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in blood and BM samples from MDS-patients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feld 7"/>
          <p:cNvSpPr txBox="1"/>
          <p:nvPr/>
        </p:nvSpPr>
        <p:spPr>
          <a:xfrm>
            <a:off x="1004817" y="2761353"/>
            <a:ext cx="2645409" cy="430887"/>
          </a:xfrm>
          <a:prstGeom prst="rect">
            <a:avLst/>
          </a:prstGeom>
          <a:noFill/>
        </p:spPr>
        <p:txBody>
          <a:bodyPr wrap="square" lIns="36000" tIns="0" rIns="36000" bIns="0" rtlCol="0">
            <a:spAutoFit/>
          </a:bodyPr>
          <a:lstStyle/>
          <a:p>
            <a:pPr algn="just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7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In </a:t>
            </a: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this </a:t>
            </a:r>
            <a:r>
              <a:rPr lang="en-U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analysis</a:t>
            </a: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we included only patients in whom enough events (≥ 20) in the </a:t>
            </a:r>
            <a:r>
              <a:rPr lang="en-US" sz="7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yPC</a:t>
            </a:r>
            <a:r>
              <a:rPr lang="en-U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 compartment could be detected. Abbreviations: FCM, flow cytometry; BM, bone marrow; </a:t>
            </a:r>
            <a:r>
              <a:rPr lang="en-US" sz="7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yPC</a:t>
            </a:r>
            <a:r>
              <a:rPr lang="en-U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, myeloid progenitor cells; w/o, without. 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feld 9"/>
          <p:cNvSpPr txBox="1"/>
          <p:nvPr/>
        </p:nvSpPr>
        <p:spPr>
          <a:xfrm>
            <a:off x="1004817" y="6932114"/>
            <a:ext cx="2712529" cy="579504"/>
          </a:xfrm>
          <a:prstGeom prst="rect">
            <a:avLst/>
          </a:prstGeom>
          <a:noFill/>
        </p:spPr>
        <p:txBody>
          <a:bodyPr wrap="square" lIns="20250" tIns="20250" rIns="20250" bIns="20250" rtlCol="0">
            <a:spAutoFit/>
          </a:bodyPr>
          <a:lstStyle/>
          <a:p>
            <a:pPr algn="just"/>
            <a:r>
              <a:rPr lang="en-US" sz="7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en-U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hese patients’ samples could not be evaluated by </a:t>
            </a:r>
            <a:r>
              <a:rPr lang="en-US" sz="7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ytomorphology</a:t>
            </a:r>
            <a:r>
              <a:rPr lang="en-U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 because of lacking BM crumps. However, these patients were diagnosed according with WHO2022 classification implementing histopathology, </a:t>
            </a: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ytogenetics and / or mutational profiling. Abbreviations: FCM, flow </a:t>
            </a: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cytometry; </a:t>
            </a:r>
            <a:r>
              <a:rPr lang="en-U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BM, bone marrow.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8355717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8" name="Textfeld 57"/>
          <p:cNvSpPr txBox="1"/>
          <p:nvPr/>
        </p:nvSpPr>
        <p:spPr>
          <a:xfrm>
            <a:off x="1000063" y="-28973"/>
            <a:ext cx="4702626" cy="4099002"/>
          </a:xfrm>
          <a:prstGeom prst="rect">
            <a:avLst/>
          </a:prstGeom>
          <a:noFill/>
        </p:spPr>
        <p:txBody>
          <a:bodyPr wrap="square" lIns="36000" tIns="36000" rIns="36000" bIns="0" rtlCol="0">
            <a:spAutoFit/>
          </a:bodyPr>
          <a:lstStyle/>
          <a:p>
            <a:pPr algn="just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 FCM-panel (A), gating strategy and an example of a FCM-measurement in 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lood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of a healthy donor in 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ube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1 (B) and 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ube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2 (C). </a:t>
            </a:r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(A) The </a:t>
            </a:r>
            <a:r>
              <a:rPr lang="en-US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antigens detected in tube 1 and 2 colored </a:t>
            </a:r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in grey are included in the final MDS-PB panel. The </a:t>
            </a:r>
            <a:r>
              <a:rPr lang="en-US" sz="105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oolean</a:t>
            </a:r>
            <a:r>
              <a:rPr lang="en-US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 gating strategy is illustrated for a healthy blood donor analysis for (B) tube 1 and (C) tube 2 with the gating hierarchy shown on the left side. First, doublets (FSC-</a:t>
            </a:r>
            <a:r>
              <a:rPr lang="en-US" sz="105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ight</a:t>
            </a:r>
            <a:r>
              <a:rPr lang="en-US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 vs. FSC-Area) and debris (FCS-Area vs. SSC-Area) are excluded (not shown)</a:t>
            </a:r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 in both </a:t>
            </a:r>
            <a:r>
              <a:rPr lang="en-US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tubes</a:t>
            </a:r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en-US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Second, </a:t>
            </a:r>
            <a:r>
              <a:rPr lang="en-US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CD45 </a:t>
            </a:r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vs. </a:t>
            </a:r>
            <a:r>
              <a:rPr lang="en-US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SSC-A plot (upper left) is used to gate all CD45+ leukocytes followed by </a:t>
            </a:r>
            <a:r>
              <a:rPr lang="en-US" sz="105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granulopoiesis</a:t>
            </a:r>
            <a:r>
              <a:rPr lang="en-US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 (green) after excluding eosinophils (violet), and lymphocytes (light blue). </a:t>
            </a:r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In the upper right plot the analysis of CD10+ and CD34+ </a:t>
            </a:r>
            <a:r>
              <a:rPr lang="en-US" sz="1050" dirty="0" err="1">
                <a:latin typeface="Arial" panose="020B0604020202020204" pitchFamily="34" charset="0"/>
                <a:cs typeface="Arial" panose="020B0604020202020204" pitchFamily="34" charset="0"/>
              </a:rPr>
              <a:t>granulopoiesis</a:t>
            </a:r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 is shown as an example of </a:t>
            </a:r>
            <a:r>
              <a:rPr lang="en-US" sz="1050" dirty="0" err="1">
                <a:latin typeface="Arial" panose="020B0604020202020204" pitchFamily="34" charset="0"/>
                <a:cs typeface="Arial" panose="020B0604020202020204" pitchFamily="34" charset="0"/>
              </a:rPr>
              <a:t>granulopoiesis</a:t>
            </a:r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’ subpopulations to be analyzed in tube 1</a:t>
            </a:r>
            <a:r>
              <a:rPr lang="en-US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. For gating of </a:t>
            </a:r>
            <a:r>
              <a:rPr lang="en-US" sz="105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yPC</a:t>
            </a:r>
            <a:r>
              <a:rPr lang="en-US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 (red) we combined CD45+ cells with low SSC (upper left) and CD34+ cells (lower left) followed </a:t>
            </a:r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by </a:t>
            </a:r>
            <a:r>
              <a:rPr lang="en-US" sz="105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ackgating</a:t>
            </a:r>
            <a:r>
              <a:rPr lang="en-US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 on CD45</a:t>
            </a:r>
            <a:r>
              <a:rPr lang="en-US" sz="105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dim</a:t>
            </a:r>
            <a:r>
              <a:rPr lang="en-US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 in CD45 vs. SSC-A plot (lower right). </a:t>
            </a:r>
          </a:p>
          <a:p>
            <a:pPr algn="just"/>
            <a:r>
              <a:rPr lang="en-US" sz="105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onopoiesis</a:t>
            </a:r>
            <a:r>
              <a:rPr lang="en-US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 has been analyzed in tube 2 (C). For rough gating, we used the CD45++</a:t>
            </a:r>
            <a:r>
              <a:rPr lang="en-US" sz="105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SC</a:t>
            </a:r>
            <a:r>
              <a:rPr lang="en-US" sz="1050" baseline="30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nt</a:t>
            </a:r>
            <a:r>
              <a:rPr lang="en-US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 cells shown in (B). This was followed by cleaning up this population including only the CD14+CD64</a:t>
            </a:r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++ </a:t>
            </a:r>
            <a:r>
              <a:rPr lang="en-US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cells as </a:t>
            </a:r>
            <a:r>
              <a:rPr lang="en-US" sz="105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onopoiesis</a:t>
            </a:r>
            <a:r>
              <a:rPr lang="en-US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 (upper left). </a:t>
            </a:r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lassical (orange) and non-classical (dark blue) monocytes are distinguished considering their different CD14/CD16 expression (upper right). CD56 expression of all three cell compartments was analyzed as shown in the lower right plot (SSC vs. CD56). Abbreviations: FCM, flow cytometry; Gran, </a:t>
            </a:r>
            <a:r>
              <a:rPr lang="en-US" sz="105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granulopoiesis</a:t>
            </a:r>
            <a:r>
              <a:rPr lang="en-US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; Eos, eosinophils; </a:t>
            </a:r>
            <a:r>
              <a:rPr lang="en-US" sz="105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ympho</a:t>
            </a:r>
            <a:r>
              <a:rPr lang="en-US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, lymphocytes; </a:t>
            </a:r>
            <a:r>
              <a:rPr lang="en-US" sz="105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yPC</a:t>
            </a:r>
            <a:r>
              <a:rPr lang="en-US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, myeloid progenitors; Mono, </a:t>
            </a:r>
            <a:r>
              <a:rPr lang="en-US" sz="105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onopoiesis</a:t>
            </a:r>
            <a:r>
              <a:rPr lang="en-US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; C, classical and NC, non-classical monocytes; FSC, forward scatter; SSC, sideward scatter.</a:t>
            </a:r>
          </a:p>
        </p:txBody>
      </p:sp>
    </p:spTree>
    <p:extLst>
      <p:ext uri="{BB962C8B-B14F-4D97-AF65-F5344CB8AC3E}">
        <p14:creationId xmlns:p14="http://schemas.microsoft.com/office/powerpoint/2010/main" val="240227634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" name="Grafik 20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228590" y="3280300"/>
            <a:ext cx="1409700" cy="1571625"/>
          </a:xfrm>
          <a:prstGeom prst="rect">
            <a:avLst/>
          </a:prstGeom>
        </p:spPr>
      </p:pic>
      <p:pic>
        <p:nvPicPr>
          <p:cNvPr id="10" name="Grafik 9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267531" y="5918955"/>
            <a:ext cx="1371600" cy="1533525"/>
          </a:xfrm>
          <a:prstGeom prst="rect">
            <a:avLst/>
          </a:prstGeom>
        </p:spPr>
      </p:pic>
      <p:pic>
        <p:nvPicPr>
          <p:cNvPr id="3" name="Grafik 2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281431" y="1962193"/>
            <a:ext cx="1371600" cy="1533525"/>
          </a:xfrm>
          <a:prstGeom prst="rect">
            <a:avLst/>
          </a:prstGeom>
        </p:spPr>
      </p:pic>
      <p:sp>
        <p:nvSpPr>
          <p:cNvPr id="33" name="Textfeld 32"/>
          <p:cNvSpPr txBox="1"/>
          <p:nvPr/>
        </p:nvSpPr>
        <p:spPr>
          <a:xfrm>
            <a:off x="4666528" y="3155106"/>
            <a:ext cx="87556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CD10 (PE-cy7)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feld 4"/>
          <p:cNvSpPr txBox="1"/>
          <p:nvPr/>
        </p:nvSpPr>
        <p:spPr>
          <a:xfrm>
            <a:off x="4653149" y="2182134"/>
            <a:ext cx="902320" cy="37757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square" lIns="36000" tIns="72000" rIns="36000" bIns="180000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CD34+ Gran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feld 35"/>
          <p:cNvSpPr txBox="1"/>
          <p:nvPr/>
        </p:nvSpPr>
        <p:spPr>
          <a:xfrm rot="5400000">
            <a:off x="4814296" y="2368105"/>
            <a:ext cx="931271" cy="55932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square" lIns="36000" tIns="36000" rIns="36000" bIns="396000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CD10+ Gran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" name="Grafik 7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270994" y="4661655"/>
            <a:ext cx="1371600" cy="1533525"/>
          </a:xfrm>
          <a:prstGeom prst="rect">
            <a:avLst/>
          </a:prstGeom>
        </p:spPr>
      </p:pic>
      <p:sp>
        <p:nvSpPr>
          <p:cNvPr id="40" name="Textfeld 39"/>
          <p:cNvSpPr txBox="1"/>
          <p:nvPr/>
        </p:nvSpPr>
        <p:spPr>
          <a:xfrm rot="16200000">
            <a:off x="4258933" y="5192883"/>
            <a:ext cx="92044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CD16 (APC-H7)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feld 43"/>
          <p:cNvSpPr txBox="1"/>
          <p:nvPr/>
        </p:nvSpPr>
        <p:spPr>
          <a:xfrm>
            <a:off x="4607812" y="5886896"/>
            <a:ext cx="101983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CD14 (</a:t>
            </a:r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erCP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5.5)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feld 47"/>
          <p:cNvSpPr txBox="1"/>
          <p:nvPr/>
        </p:nvSpPr>
        <p:spPr>
          <a:xfrm rot="16200000">
            <a:off x="4510149" y="6202452"/>
            <a:ext cx="3962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SSC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feld 48"/>
          <p:cNvSpPr txBox="1"/>
          <p:nvPr/>
        </p:nvSpPr>
        <p:spPr>
          <a:xfrm>
            <a:off x="4707073" y="7180839"/>
            <a:ext cx="77136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CD56 (FITC)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Textfeld 63"/>
          <p:cNvSpPr txBox="1"/>
          <p:nvPr/>
        </p:nvSpPr>
        <p:spPr>
          <a:xfrm rot="5400000">
            <a:off x="4822004" y="6396131"/>
            <a:ext cx="944385" cy="52879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square" lIns="36000" tIns="36000" rIns="0" bIns="0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CD56+: </a:t>
            </a:r>
          </a:p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Gran, Mono, </a:t>
            </a:r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yPC</a:t>
            </a:r>
            <a:endParaRPr lang="en-US" sz="8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Grafik 5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012350" y="4816892"/>
            <a:ext cx="2419350" cy="2590800"/>
          </a:xfrm>
          <a:prstGeom prst="rect">
            <a:avLst/>
          </a:prstGeom>
        </p:spPr>
      </p:pic>
      <p:sp>
        <p:nvSpPr>
          <p:cNvPr id="39" name="Textfeld 38"/>
          <p:cNvSpPr txBox="1"/>
          <p:nvPr/>
        </p:nvSpPr>
        <p:spPr>
          <a:xfrm>
            <a:off x="1044488" y="4844602"/>
            <a:ext cx="419823" cy="195814"/>
          </a:xfrm>
          <a:prstGeom prst="rect">
            <a:avLst/>
          </a:prstGeom>
          <a:solidFill>
            <a:schemeClr val="bg1"/>
          </a:solidFill>
        </p:spPr>
        <p:txBody>
          <a:bodyPr wrap="square" lIns="36000" tIns="36000" rIns="36000" bIns="36000" rtlCol="0">
            <a:spAutoFit/>
          </a:bodyPr>
          <a:lstStyle/>
          <a:p>
            <a:r>
              <a:rPr lang="en-US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ube 2                                 </a:t>
            </a: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feld 40"/>
          <p:cNvSpPr txBox="1"/>
          <p:nvPr/>
        </p:nvSpPr>
        <p:spPr>
          <a:xfrm>
            <a:off x="961640" y="4662616"/>
            <a:ext cx="3257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</a:p>
        </p:txBody>
      </p:sp>
      <p:sp>
        <p:nvSpPr>
          <p:cNvPr id="71" name="Textfeld 70"/>
          <p:cNvSpPr txBox="1"/>
          <p:nvPr/>
        </p:nvSpPr>
        <p:spPr>
          <a:xfrm>
            <a:off x="1082695" y="2221014"/>
            <a:ext cx="446885" cy="195814"/>
          </a:xfrm>
          <a:prstGeom prst="rect">
            <a:avLst/>
          </a:prstGeom>
          <a:solidFill>
            <a:schemeClr val="bg1"/>
          </a:solidFill>
        </p:spPr>
        <p:txBody>
          <a:bodyPr wrap="square" lIns="36000" tIns="36000" rIns="36000" bIns="36000" rtlCol="0">
            <a:spAutoFit/>
          </a:bodyPr>
          <a:lstStyle/>
          <a:p>
            <a:r>
              <a:rPr lang="en-US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ube 1                                 </a:t>
            </a: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feld 11"/>
          <p:cNvSpPr txBox="1"/>
          <p:nvPr/>
        </p:nvSpPr>
        <p:spPr>
          <a:xfrm>
            <a:off x="960314" y="2021619"/>
            <a:ext cx="32092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</a:p>
        </p:txBody>
      </p:sp>
      <p:sp>
        <p:nvSpPr>
          <p:cNvPr id="35" name="Textfeld 34"/>
          <p:cNvSpPr txBox="1"/>
          <p:nvPr/>
        </p:nvSpPr>
        <p:spPr>
          <a:xfrm>
            <a:off x="4727402" y="1990454"/>
            <a:ext cx="80983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Gran w/o Eos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feld 37"/>
          <p:cNvSpPr txBox="1"/>
          <p:nvPr/>
        </p:nvSpPr>
        <p:spPr>
          <a:xfrm>
            <a:off x="4582378" y="3329767"/>
            <a:ext cx="101822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Blasts and CD34+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feld 42"/>
          <p:cNvSpPr txBox="1"/>
          <p:nvPr/>
        </p:nvSpPr>
        <p:spPr>
          <a:xfrm>
            <a:off x="4517219" y="4706322"/>
            <a:ext cx="118333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Mono (CD14+CD64+)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feld 44"/>
          <p:cNvSpPr txBox="1"/>
          <p:nvPr/>
        </p:nvSpPr>
        <p:spPr>
          <a:xfrm>
            <a:off x="4564444" y="6019076"/>
            <a:ext cx="106792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Gran, Mono, Blasts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7" name="Grafik 16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159465" y="1944972"/>
            <a:ext cx="1354075" cy="1533525"/>
          </a:xfrm>
          <a:prstGeom prst="rect">
            <a:avLst/>
          </a:prstGeom>
        </p:spPr>
      </p:pic>
      <p:sp>
        <p:nvSpPr>
          <p:cNvPr id="34" name="Textfeld 33"/>
          <p:cNvSpPr txBox="1"/>
          <p:nvPr/>
        </p:nvSpPr>
        <p:spPr>
          <a:xfrm rot="16200000">
            <a:off x="4014403" y="2502156"/>
            <a:ext cx="101983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CD34 (</a:t>
            </a:r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erCP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5.5)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feld 13"/>
          <p:cNvSpPr txBox="1"/>
          <p:nvPr/>
        </p:nvSpPr>
        <p:spPr>
          <a:xfrm>
            <a:off x="3635557" y="1987412"/>
            <a:ext cx="77777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NOT (debris)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feld 46"/>
          <p:cNvSpPr txBox="1"/>
          <p:nvPr/>
        </p:nvSpPr>
        <p:spPr>
          <a:xfrm rot="16200000">
            <a:off x="3400300" y="2199659"/>
            <a:ext cx="3962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SSC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feld 30"/>
          <p:cNvSpPr txBox="1"/>
          <p:nvPr/>
        </p:nvSpPr>
        <p:spPr>
          <a:xfrm rot="5400000">
            <a:off x="3624752" y="2354066"/>
            <a:ext cx="950104" cy="55932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square" lIns="36000" tIns="36000" rIns="36000" bIns="396000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CD45+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Rechteck 1"/>
          <p:cNvSpPr/>
          <p:nvPr/>
        </p:nvSpPr>
        <p:spPr>
          <a:xfrm>
            <a:off x="1000063" y="1993751"/>
            <a:ext cx="4705743" cy="5381619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7" name="Grafik 6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028837" y="2198514"/>
            <a:ext cx="2333625" cy="2343150"/>
          </a:xfrm>
          <a:prstGeom prst="rect">
            <a:avLst/>
          </a:prstGeom>
        </p:spPr>
      </p:pic>
      <p:sp>
        <p:nvSpPr>
          <p:cNvPr id="51" name="Textfeld 50"/>
          <p:cNvSpPr txBox="1"/>
          <p:nvPr/>
        </p:nvSpPr>
        <p:spPr>
          <a:xfrm rot="16200000">
            <a:off x="4529020" y="3532462"/>
            <a:ext cx="3962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SSC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Textfeld 51"/>
          <p:cNvSpPr txBox="1"/>
          <p:nvPr/>
        </p:nvSpPr>
        <p:spPr>
          <a:xfrm>
            <a:off x="4704481" y="4473403"/>
            <a:ext cx="81464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CD45 (V 500)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feld 53"/>
          <p:cNvSpPr txBox="1"/>
          <p:nvPr/>
        </p:nvSpPr>
        <p:spPr>
          <a:xfrm>
            <a:off x="4936959" y="4187026"/>
            <a:ext cx="180871" cy="1846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square" lIns="36000" tIns="72000" rIns="36000" bIns="144000" rtlCol="0">
            <a:spAutoFit/>
          </a:bodyPr>
          <a:lstStyle/>
          <a:p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Textfeld 55"/>
          <p:cNvSpPr txBox="1"/>
          <p:nvPr/>
        </p:nvSpPr>
        <p:spPr>
          <a:xfrm>
            <a:off x="4896078" y="3987906"/>
            <a:ext cx="401475" cy="195814"/>
          </a:xfrm>
          <a:prstGeom prst="rect">
            <a:avLst/>
          </a:prstGeom>
          <a:noFill/>
          <a:ln>
            <a:noFill/>
          </a:ln>
        </p:spPr>
        <p:txBody>
          <a:bodyPr wrap="square" lIns="36000" tIns="36000" rIns="36000" bIns="36000" rtlCol="0">
            <a:spAutoFit/>
          </a:bodyPr>
          <a:lstStyle/>
          <a:p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yPC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6" name="Grafik 25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169916" y="4660272"/>
            <a:ext cx="1371600" cy="1533525"/>
          </a:xfrm>
          <a:prstGeom prst="rect">
            <a:avLst/>
          </a:prstGeom>
        </p:spPr>
      </p:pic>
      <p:sp>
        <p:nvSpPr>
          <p:cNvPr id="62" name="Textfeld 61"/>
          <p:cNvSpPr txBox="1"/>
          <p:nvPr/>
        </p:nvSpPr>
        <p:spPr>
          <a:xfrm>
            <a:off x="3669825" y="4709619"/>
            <a:ext cx="64152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Mono (all)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Textfeld 62"/>
          <p:cNvSpPr txBox="1"/>
          <p:nvPr/>
        </p:nvSpPr>
        <p:spPr>
          <a:xfrm>
            <a:off x="3512437" y="5886896"/>
            <a:ext cx="101983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CD14 (</a:t>
            </a:r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erCP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5.5)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Textfeld 64"/>
          <p:cNvSpPr txBox="1"/>
          <p:nvPr/>
        </p:nvSpPr>
        <p:spPr>
          <a:xfrm rot="16200000">
            <a:off x="3176476" y="5145258"/>
            <a:ext cx="87556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CD64 (PE-cy7)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Textfeld 65"/>
          <p:cNvSpPr txBox="1"/>
          <p:nvPr/>
        </p:nvSpPr>
        <p:spPr>
          <a:xfrm rot="18401958">
            <a:off x="3980296" y="4996812"/>
            <a:ext cx="443097" cy="35319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square" lIns="36000" tIns="36000" rIns="36000" bIns="0" rtlCol="0">
            <a:spAutoFit/>
          </a:bodyPr>
          <a:lstStyle/>
          <a:p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Textfeld 66"/>
          <p:cNvSpPr txBox="1"/>
          <p:nvPr/>
        </p:nvSpPr>
        <p:spPr>
          <a:xfrm>
            <a:off x="3512437" y="5629144"/>
            <a:ext cx="1001103" cy="232165"/>
          </a:xfrm>
          <a:prstGeom prst="rect">
            <a:avLst/>
          </a:prstGeom>
          <a:noFill/>
          <a:ln>
            <a:noFill/>
          </a:ln>
        </p:spPr>
        <p:txBody>
          <a:bodyPr wrap="square" lIns="36000" tIns="72000" rIns="36000" bIns="36000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Mono CD14+CD64+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53" name="Tabelle 5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29786595"/>
              </p:ext>
            </p:extLst>
          </p:nvPr>
        </p:nvGraphicFramePr>
        <p:xfrm>
          <a:off x="1010696" y="1210254"/>
          <a:ext cx="4705743" cy="79776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462977">
                  <a:extLst>
                    <a:ext uri="{9D8B030D-6E8A-4147-A177-3AD203B41FA5}">
                      <a16:colId xmlns:a16="http://schemas.microsoft.com/office/drawing/2014/main" val="2137522838"/>
                    </a:ext>
                  </a:extLst>
                </a:gridCol>
                <a:gridCol w="548333">
                  <a:extLst>
                    <a:ext uri="{9D8B030D-6E8A-4147-A177-3AD203B41FA5}">
                      <a16:colId xmlns:a16="http://schemas.microsoft.com/office/drawing/2014/main" val="4018632304"/>
                    </a:ext>
                  </a:extLst>
                </a:gridCol>
                <a:gridCol w="540996">
                  <a:extLst>
                    <a:ext uri="{9D8B030D-6E8A-4147-A177-3AD203B41FA5}">
                      <a16:colId xmlns:a16="http://schemas.microsoft.com/office/drawing/2014/main" val="340932052"/>
                    </a:ext>
                  </a:extLst>
                </a:gridCol>
                <a:gridCol w="564542">
                  <a:extLst>
                    <a:ext uri="{9D8B030D-6E8A-4147-A177-3AD203B41FA5}">
                      <a16:colId xmlns:a16="http://schemas.microsoft.com/office/drawing/2014/main" val="1667995137"/>
                    </a:ext>
                  </a:extLst>
                </a:gridCol>
                <a:gridCol w="578586">
                  <a:extLst>
                    <a:ext uri="{9D8B030D-6E8A-4147-A177-3AD203B41FA5}">
                      <a16:colId xmlns:a16="http://schemas.microsoft.com/office/drawing/2014/main" val="830147403"/>
                    </a:ext>
                  </a:extLst>
                </a:gridCol>
                <a:gridCol w="486622">
                  <a:extLst>
                    <a:ext uri="{9D8B030D-6E8A-4147-A177-3AD203B41FA5}">
                      <a16:colId xmlns:a16="http://schemas.microsoft.com/office/drawing/2014/main" val="3383604136"/>
                    </a:ext>
                  </a:extLst>
                </a:gridCol>
                <a:gridCol w="550442">
                  <a:extLst>
                    <a:ext uri="{9D8B030D-6E8A-4147-A177-3AD203B41FA5}">
                      <a16:colId xmlns:a16="http://schemas.microsoft.com/office/drawing/2014/main" val="2164345890"/>
                    </a:ext>
                  </a:extLst>
                </a:gridCol>
                <a:gridCol w="470668">
                  <a:extLst>
                    <a:ext uri="{9D8B030D-6E8A-4147-A177-3AD203B41FA5}">
                      <a16:colId xmlns:a16="http://schemas.microsoft.com/office/drawing/2014/main" val="2135977447"/>
                    </a:ext>
                  </a:extLst>
                </a:gridCol>
                <a:gridCol w="502577">
                  <a:extLst>
                    <a:ext uri="{9D8B030D-6E8A-4147-A177-3AD203B41FA5}">
                      <a16:colId xmlns:a16="http://schemas.microsoft.com/office/drawing/2014/main" val="347034879"/>
                    </a:ext>
                  </a:extLst>
                </a:gridCol>
              </a:tblGrid>
              <a:tr h="144000">
                <a:tc>
                  <a:txBody>
                    <a:bodyPr/>
                    <a:lstStyle/>
                    <a:p>
                      <a:r>
                        <a:rPr lang="en-US" sz="8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A)</a:t>
                      </a:r>
                      <a:endParaRPr lang="en-US" sz="8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2000" marR="5200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ITC</a:t>
                      </a:r>
                    </a:p>
                  </a:txBody>
                  <a:tcPr marL="52000" marR="5200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</a:t>
                      </a:r>
                    </a:p>
                  </a:txBody>
                  <a:tcPr marL="52000" marR="5200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rCP5.5</a:t>
                      </a:r>
                    </a:p>
                  </a:txBody>
                  <a:tcPr marL="52000" marR="5200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-cy7</a:t>
                      </a:r>
                    </a:p>
                  </a:txBody>
                  <a:tcPr marL="52000" marR="5200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PC</a:t>
                      </a:r>
                    </a:p>
                  </a:txBody>
                  <a:tcPr marL="52000" marR="5200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PC-H7</a:t>
                      </a:r>
                    </a:p>
                  </a:txBody>
                  <a:tcPr marL="52000" marR="5200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B</a:t>
                      </a:r>
                    </a:p>
                  </a:txBody>
                  <a:tcPr marL="52000" marR="5200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500</a:t>
                      </a:r>
                    </a:p>
                  </a:txBody>
                  <a:tcPr marL="52000" marR="5200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43193390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r>
                        <a:rPr lang="en-US" sz="8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ube 1</a:t>
                      </a:r>
                      <a:endParaRPr lang="en-US" sz="8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2000" marR="5200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8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66</a:t>
                      </a:r>
                      <a:endParaRPr lang="en-US" sz="8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2000" marR="5200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8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13</a:t>
                      </a:r>
                      <a:endParaRPr lang="en-US" sz="8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2000" marR="5200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8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34</a:t>
                      </a:r>
                      <a:endParaRPr lang="en-US" sz="8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2000" marR="5200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8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10</a:t>
                      </a:r>
                      <a:endParaRPr lang="en-US" sz="8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2000" marR="5200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8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177</a:t>
                      </a:r>
                      <a:endParaRPr lang="en-US" sz="8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2000" marR="5200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8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16</a:t>
                      </a:r>
                      <a:endParaRPr lang="en-US" sz="8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2000" marR="5200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8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11b</a:t>
                      </a:r>
                      <a:endParaRPr lang="en-US" sz="8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2000" marR="5200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8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45</a:t>
                      </a:r>
                      <a:endParaRPr lang="en-US" sz="8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2000" marR="5200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64646675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endParaRPr lang="en-US" sz="6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2000" marR="5200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6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D </a:t>
                      </a:r>
                    </a:p>
                    <a:p>
                      <a:r>
                        <a:rPr lang="en-US" sz="6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551479)</a:t>
                      </a:r>
                      <a:endParaRPr lang="en-US" sz="6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2000" marR="5200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6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D </a:t>
                      </a:r>
                    </a:p>
                    <a:p>
                      <a:r>
                        <a:rPr lang="en-US" sz="6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347406)</a:t>
                      </a:r>
                      <a:endParaRPr lang="en-US" sz="6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2000" marR="5200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6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D </a:t>
                      </a:r>
                    </a:p>
                    <a:p>
                      <a:r>
                        <a:rPr lang="en-US" sz="6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347222)</a:t>
                      </a:r>
                      <a:endParaRPr lang="en-US" sz="6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2000" marR="5200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6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D </a:t>
                      </a:r>
                    </a:p>
                    <a:p>
                      <a:r>
                        <a:rPr lang="en-US" sz="6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341112)</a:t>
                      </a:r>
                      <a:endParaRPr lang="en-US" sz="6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2000" marR="5200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6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LD (315807)</a:t>
                      </a:r>
                      <a:endParaRPr lang="en-US" sz="6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2000" marR="5200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6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D </a:t>
                      </a:r>
                    </a:p>
                    <a:p>
                      <a:r>
                        <a:rPr lang="en-US" sz="6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561306)</a:t>
                      </a:r>
                      <a:endParaRPr lang="en-US" sz="6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2000" marR="5200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6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LD (301315)</a:t>
                      </a:r>
                      <a:endParaRPr lang="en-US" sz="6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2000" marR="5200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6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D (560777)</a:t>
                      </a:r>
                      <a:endParaRPr lang="en-US" sz="6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2000" marR="5200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36515866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r>
                        <a:rPr lang="en-US" sz="8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ube 2</a:t>
                      </a:r>
                      <a:endParaRPr lang="en-US" sz="8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2000" marR="5200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8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56</a:t>
                      </a:r>
                      <a:endParaRPr lang="en-US" sz="8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2000" marR="5200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8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116</a:t>
                      </a:r>
                      <a:endParaRPr lang="en-US" sz="8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2000" marR="5200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8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14</a:t>
                      </a:r>
                      <a:endParaRPr lang="en-US" sz="8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2000" marR="5200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8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64</a:t>
                      </a:r>
                      <a:endParaRPr lang="en-US" sz="8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2000" marR="5200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8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11a</a:t>
                      </a:r>
                      <a:endParaRPr lang="en-US" sz="8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2000" marR="5200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8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16</a:t>
                      </a:r>
                      <a:endParaRPr lang="en-US" sz="8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2000" marR="5200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8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11b</a:t>
                      </a:r>
                      <a:endParaRPr lang="en-US" sz="8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2000" marR="5200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8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45</a:t>
                      </a:r>
                      <a:endParaRPr lang="en-US" sz="8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2000" marR="5200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25912316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endParaRPr lang="en-US" sz="6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2000" marR="5200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6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D </a:t>
                      </a:r>
                    </a:p>
                    <a:p>
                      <a:r>
                        <a:rPr lang="en-US" sz="6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345811)</a:t>
                      </a:r>
                      <a:endParaRPr lang="en-US" sz="6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2000" marR="5200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6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D </a:t>
                      </a:r>
                    </a:p>
                    <a:p>
                      <a:r>
                        <a:rPr lang="en-US" sz="6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551373)</a:t>
                      </a:r>
                      <a:endParaRPr lang="en-US" sz="6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2000" marR="5200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6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LD (325622)</a:t>
                      </a:r>
                      <a:endParaRPr lang="en-US" sz="6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2000" marR="5200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6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LD (305022)</a:t>
                      </a:r>
                      <a:endParaRPr lang="en-US" sz="6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2000" marR="5200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6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D (550852)</a:t>
                      </a:r>
                      <a:endParaRPr lang="en-US" sz="6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2000" marR="5200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6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D </a:t>
                      </a:r>
                    </a:p>
                    <a:p>
                      <a:r>
                        <a:rPr lang="en-US" sz="6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561306)</a:t>
                      </a:r>
                    </a:p>
                  </a:txBody>
                  <a:tcPr marL="52000" marR="5200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6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LD (301315)</a:t>
                      </a:r>
                      <a:endParaRPr lang="en-US" sz="6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2000" marR="5200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6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D (560777)</a:t>
                      </a:r>
                      <a:endParaRPr lang="en-US" sz="6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2000" marR="52000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25952215"/>
                  </a:ext>
                </a:extLst>
              </a:tr>
            </a:tbl>
          </a:graphicData>
        </a:graphic>
      </p:graphicFrame>
      <p:pic>
        <p:nvPicPr>
          <p:cNvPr id="11" name="Grafik 10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3166816" y="3297919"/>
            <a:ext cx="1371600" cy="1533525"/>
          </a:xfrm>
          <a:prstGeom prst="rect">
            <a:avLst/>
          </a:prstGeom>
        </p:spPr>
      </p:pic>
      <p:cxnSp>
        <p:nvCxnSpPr>
          <p:cNvPr id="20" name="Gerader Verbinder 19"/>
          <p:cNvCxnSpPr/>
          <p:nvPr/>
        </p:nvCxnSpPr>
        <p:spPr>
          <a:xfrm>
            <a:off x="1000063" y="4690345"/>
            <a:ext cx="4702626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" name="Textfeld 54"/>
          <p:cNvSpPr txBox="1"/>
          <p:nvPr/>
        </p:nvSpPr>
        <p:spPr>
          <a:xfrm>
            <a:off x="3598431" y="3171561"/>
            <a:ext cx="81464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CD45 (V 500)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Textfeld 58"/>
          <p:cNvSpPr txBox="1"/>
          <p:nvPr/>
        </p:nvSpPr>
        <p:spPr>
          <a:xfrm>
            <a:off x="3479660" y="4489620"/>
            <a:ext cx="101983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CD34 (</a:t>
            </a:r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erCP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5.5)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feld 41"/>
          <p:cNvSpPr txBox="1"/>
          <p:nvPr/>
        </p:nvSpPr>
        <p:spPr>
          <a:xfrm>
            <a:off x="3745095" y="3332794"/>
            <a:ext cx="50687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CD45+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feld 45"/>
          <p:cNvSpPr txBox="1"/>
          <p:nvPr/>
        </p:nvSpPr>
        <p:spPr>
          <a:xfrm rot="16200000">
            <a:off x="3424501" y="3542128"/>
            <a:ext cx="3962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SSC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feld 49"/>
          <p:cNvSpPr txBox="1"/>
          <p:nvPr/>
        </p:nvSpPr>
        <p:spPr>
          <a:xfrm>
            <a:off x="3927852" y="4173983"/>
            <a:ext cx="447766" cy="21655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square" lIns="36000" tIns="36000" rIns="36000" bIns="0" rtlCol="0">
            <a:spAutoFit/>
          </a:bodyPr>
          <a:lstStyle/>
          <a:p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feld 56"/>
          <p:cNvSpPr txBox="1"/>
          <p:nvPr/>
        </p:nvSpPr>
        <p:spPr>
          <a:xfrm>
            <a:off x="3996600" y="3976949"/>
            <a:ext cx="432023" cy="232165"/>
          </a:xfrm>
          <a:prstGeom prst="rect">
            <a:avLst/>
          </a:prstGeom>
          <a:noFill/>
          <a:ln>
            <a:noFill/>
          </a:ln>
        </p:spPr>
        <p:txBody>
          <a:bodyPr wrap="square" lIns="36000" tIns="72000" rIns="36000" bIns="36000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CD34+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530498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252</Words>
  <Application>Microsoft Office PowerPoint</Application>
  <PresentationFormat>A4-Papier (210 x 297 mm)</PresentationFormat>
  <Paragraphs>254</Paragraphs>
  <Slides>4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</vt:lpstr>
      <vt:lpstr>PowerPoint-Präsentation</vt:lpstr>
      <vt:lpstr>PowerPoint-Präsentation</vt:lpstr>
      <vt:lpstr>PowerPoint-Präsentation</vt:lpstr>
      <vt:lpstr>PowerPoint-Präsentation</vt:lpstr>
    </vt:vector>
  </TitlesOfParts>
  <Company>Universitätsklinik Carl Gustav Carus Dresde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Oelschlaegel, Uta</dc:creator>
  <cp:lastModifiedBy>Oelschlaegel, Uta</cp:lastModifiedBy>
  <cp:revision>125</cp:revision>
  <cp:lastPrinted>2023-12-05T07:34:19Z</cp:lastPrinted>
  <dcterms:created xsi:type="dcterms:W3CDTF">2023-07-11T08:07:05Z</dcterms:created>
  <dcterms:modified xsi:type="dcterms:W3CDTF">2024-01-02T11:40:52Z</dcterms:modified>
</cp:coreProperties>
</file>